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6" r:id="rId3"/>
    <p:sldId id="257" r:id="rId4"/>
    <p:sldId id="260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931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36D8-C87C-4B80-8630-69C715EBC5DF}" type="datetimeFigureOut">
              <a:rPr lang="zh-CN" altLang="en-US" smtClean="0"/>
              <a:pPr/>
              <a:t>2025/11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10D5-77CB-43F5-9B24-C26BC244EDF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36D8-C87C-4B80-8630-69C715EBC5DF}" type="datetimeFigureOut">
              <a:rPr lang="zh-CN" altLang="en-US" smtClean="0"/>
              <a:pPr/>
              <a:t>2025/11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10D5-77CB-43F5-9B24-C26BC244EDF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36D8-C87C-4B80-8630-69C715EBC5DF}" type="datetimeFigureOut">
              <a:rPr lang="zh-CN" altLang="en-US" smtClean="0"/>
              <a:pPr/>
              <a:t>2025/11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10D5-77CB-43F5-9B24-C26BC244EDF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36D8-C87C-4B80-8630-69C715EBC5DF}" type="datetimeFigureOut">
              <a:rPr lang="zh-CN" altLang="en-US" smtClean="0"/>
              <a:pPr/>
              <a:t>2025/11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10D5-77CB-43F5-9B24-C26BC244EDF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36D8-C87C-4B80-8630-69C715EBC5DF}" type="datetimeFigureOut">
              <a:rPr lang="zh-CN" altLang="en-US" smtClean="0"/>
              <a:pPr/>
              <a:t>2025/11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10D5-77CB-43F5-9B24-C26BC244EDF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36D8-C87C-4B80-8630-69C715EBC5DF}" type="datetimeFigureOut">
              <a:rPr lang="zh-CN" altLang="en-US" smtClean="0"/>
              <a:pPr/>
              <a:t>2025/11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10D5-77CB-43F5-9B24-C26BC244EDF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36D8-C87C-4B80-8630-69C715EBC5DF}" type="datetimeFigureOut">
              <a:rPr lang="zh-CN" altLang="en-US" smtClean="0"/>
              <a:pPr/>
              <a:t>2025/11/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10D5-77CB-43F5-9B24-C26BC244EDF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36D8-C87C-4B80-8630-69C715EBC5DF}" type="datetimeFigureOut">
              <a:rPr lang="zh-CN" altLang="en-US" smtClean="0"/>
              <a:pPr/>
              <a:t>2025/11/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10D5-77CB-43F5-9B24-C26BC244EDF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36D8-C87C-4B80-8630-69C715EBC5DF}" type="datetimeFigureOut">
              <a:rPr lang="zh-CN" altLang="en-US" smtClean="0"/>
              <a:pPr/>
              <a:t>2025/11/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10D5-77CB-43F5-9B24-C26BC244EDF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36D8-C87C-4B80-8630-69C715EBC5DF}" type="datetimeFigureOut">
              <a:rPr lang="zh-CN" altLang="en-US" smtClean="0"/>
              <a:pPr/>
              <a:t>2025/11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10D5-77CB-43F5-9B24-C26BC244EDF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3C36D8-C87C-4B80-8630-69C715EBC5DF}" type="datetimeFigureOut">
              <a:rPr lang="zh-CN" altLang="en-US" smtClean="0"/>
              <a:pPr/>
              <a:t>2025/11/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6C10D5-77CB-43F5-9B24-C26BC244EDF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3C36D8-C87C-4B80-8630-69C715EBC5DF}" type="datetimeFigureOut">
              <a:rPr lang="zh-CN" altLang="en-US" smtClean="0"/>
              <a:pPr/>
              <a:t>2025/11/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6C10D5-77CB-43F5-9B24-C26BC244EDF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Suppl Figure 1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9846" y="785794"/>
            <a:ext cx="9088862" cy="257176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28596" y="3786190"/>
            <a:ext cx="8358246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ry Figure 1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. mRNA expression in mouse livers and 293T cells.  Heat maps showing mRNA expression changes in the livers of miR-122-knockout mice (A and B) and in 293T cells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transfected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with a miR-122 mimic (C). (A) Analyses using the GSE20610 dataset.  Gene names are listed on the left.  (B) Analyses using the GSE27713 datasets.  (C) Analyses using the GSE123311 dataset. 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Suppl Figure 2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658" y="428604"/>
            <a:ext cx="8958498" cy="3786214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71472" y="4357694"/>
            <a:ext cx="764386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Supplementary Figure 2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.  mRNA expression in 293T and HepG2 cells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transfected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with a control or miR-122 mimic.  Two days after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transfection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, total RNA was isolated, and reverse transcription and </a:t>
            </a:r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qPCR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performed to quantify the relative expression of genes indicated on the x-axis.  Y-axis is the relative mRNA expression level, with that in the control cells set at 1.  Averages and standard deviations are shown.  *: P&lt;0.05; **: P&lt;0.01. </a:t>
            </a:r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uppl Figure 3.tif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2844" y="714356"/>
            <a:ext cx="8797824" cy="264320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500034" y="3485753"/>
            <a:ext cx="7929618" cy="28007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Supplementary Figure 3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  miR-122 directly inhibits CS expression in a reporter assay.  The left panel shows the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pCMV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-Luc-CS reporter construct, with ~ 200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nt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of the 3’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untranslated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region of the CS mRNA inserted after the firefly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luciferase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coding sequence.  Location of the miR-122 targeting sequence in the CS mRNA is indicated below, and the predicted, interacting CS and miR-122 sequences shown in red.  A mutant reporter was also constructed with the CS sequence in red deleted.  The right panel shows results of the reporter assays.  293T cells were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transfected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with the CS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wildtype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or mutant reporter, along with a control or miR-122 mimic RNA.  Two days later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luciferase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activities were measured using a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luminometer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.   Y-axis is the relative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luciferase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activities, with that in the control RNA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transfection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set at 1.  Averages and standard deviations are shown.  These results verified the site in CS mRNA regulated by miR-122.  For details of the plasmids and luciferase assays, see reference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13. 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1406" y="1071546"/>
            <a:ext cx="8962248" cy="27146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6" name="TextBox 5"/>
          <p:cNvSpPr txBox="1"/>
          <p:nvPr/>
        </p:nvSpPr>
        <p:spPr>
          <a:xfrm>
            <a:off x="428596" y="4357694"/>
            <a:ext cx="821537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Times New Roman" pitchFamily="18" charset="0"/>
                <a:cs typeface="Times New Roman" pitchFamily="18" charset="0"/>
              </a:rPr>
              <a:t>Supplementary Figure 4</a:t>
            </a:r>
            <a:r>
              <a:rPr lang="en-US" sz="2000" dirty="0" smtClean="0">
                <a:latin typeface="Times New Roman" pitchFamily="18" charset="0"/>
                <a:cs typeface="Times New Roman" pitchFamily="18" charset="0"/>
              </a:rPr>
              <a:t>.  CS mRNA expression in human cancer samples and the adjacent normal tissues. The UALCAN platform (Ref 28) was used to analyze the TCGA project data. 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1</TotalTime>
  <Words>366</Words>
  <Application>Microsoft Office PowerPoint</Application>
  <PresentationFormat>On-screen Show (4:3)</PresentationFormat>
  <Paragraphs>4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Slide 1</vt:lpstr>
      <vt:lpstr>Slide 2</vt:lpstr>
      <vt:lpstr>Slide 3</vt:lpstr>
      <vt:lpstr>Slid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dministrator</dc:creator>
  <cp:lastModifiedBy>Yan</cp:lastModifiedBy>
  <cp:revision>42</cp:revision>
  <dcterms:created xsi:type="dcterms:W3CDTF">2025-08-29T19:22:54Z</dcterms:created>
  <dcterms:modified xsi:type="dcterms:W3CDTF">2025-11-08T07:59:42Z</dcterms:modified>
</cp:coreProperties>
</file>